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5" autoAdjust="0"/>
    <p:restoredTop sz="96096" autoAdjust="0"/>
  </p:normalViewPr>
  <p:slideViewPr>
    <p:cSldViewPr snapToGrid="0">
      <p:cViewPr varScale="1">
        <p:scale>
          <a:sx n="102" d="100"/>
          <a:sy n="102" d="100"/>
        </p:scale>
        <p:origin x="978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69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36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415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02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490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413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15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65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349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700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448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178F7-0C85-4E45-A989-E2E53B8C8631}" type="datetimeFigureOut">
              <a:rPr lang="en-US" smtClean="0"/>
              <a:t>7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FC363-F866-4201-87AB-5A93BEF47E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773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1650" y="1333500"/>
            <a:ext cx="3105150" cy="1104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3929389"/>
            <a:ext cx="3105150" cy="19050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Straight Connector 3"/>
          <p:cNvCxnSpPr/>
          <p:nvPr/>
        </p:nvCxnSpPr>
        <p:spPr>
          <a:xfrm>
            <a:off x="5581650" y="114300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V="1">
            <a:off x="5953124" y="79501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962650" y="81741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6334124" y="79501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343650" y="114300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5572124" y="345140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5943598" y="342900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953124" y="377699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6324598" y="342900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6334124" y="345140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334124" y="773668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1-U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6334124" y="348385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1-D</a:t>
            </a:r>
            <a:endParaRPr lang="en-US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6715124" y="114300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714259" y="345140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04801" y="1219974"/>
            <a:ext cx="4876800" cy="41857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 smtClean="0"/>
              <a:t>CL1: Early Transitory Stage</a:t>
            </a:r>
          </a:p>
          <a:p>
            <a:r>
              <a:rPr lang="en-US" sz="1400" b="1" dirty="0" smtClean="0"/>
              <a:t>CL1-U: Cluster 1-Upregulated pathways</a:t>
            </a:r>
            <a:r>
              <a:rPr lang="en-US" sz="1400" dirty="0" smtClean="0"/>
              <a:t>: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EIF2 Signaling  (44 genes, including RPLs EIF2.., 3..) _ TF: E2F1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Mitochondrial function (23 genes)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IGF-1 Signaling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Cell cycle control of chromosomal replication, cell cycle G1/S checkpoint regulation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Mitotic Roles of Polo-Like Kinase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Cholesterol biosynthesis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Increased cell proliferation, cell cycle progression, conditions for infection</a:t>
            </a:r>
          </a:p>
          <a:p>
            <a:endParaRPr lang="en-US" sz="1400" b="1" dirty="0" smtClean="0"/>
          </a:p>
          <a:p>
            <a:r>
              <a:rPr lang="en-US" sz="1400" b="1" dirty="0" smtClean="0"/>
              <a:t>CL1-D: Cluster </a:t>
            </a:r>
            <a:r>
              <a:rPr lang="en-US" sz="1400" b="1" dirty="0" err="1" smtClean="0"/>
              <a:t>Downregulated</a:t>
            </a:r>
            <a:r>
              <a:rPr lang="en-US" sz="1400" b="1" dirty="0" smtClean="0"/>
              <a:t> pathways</a:t>
            </a:r>
            <a:r>
              <a:rPr lang="en-US" sz="1400" dirty="0" smtClean="0"/>
              <a:t>: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Antigen presentation pathway, communication between innate and adaptive immune cells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Elements of pattern recognition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Receptor pathways, including complement components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Decreased migration of cells, phagocytosis, inflammatory response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14400" y="545068"/>
            <a:ext cx="38304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arly changes: 4.0 hour Post-Infection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334000" y="583439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</a:t>
            </a:r>
            <a:r>
              <a:rPr lang="en-US" sz="1600" b="1" dirty="0"/>
              <a:t>24 h 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334000" y="24384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 24 </a:t>
            </a:r>
            <a:r>
              <a:rPr lang="en-US" sz="1600" b="1" dirty="0"/>
              <a:t>h</a:t>
            </a:r>
            <a:r>
              <a:rPr lang="en-US" sz="1600" b="1" dirty="0" smtClean="0"/>
              <a:t> 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901234" y="6408002"/>
            <a:ext cx="1044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5A Fig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6553200" y="381000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24" name="Straight Connector 23"/>
          <p:cNvCxnSpPr>
            <a:stCxn id="2" idx="2"/>
            <a:endCxn id="23" idx="0"/>
          </p:cNvCxnSpPr>
          <p:nvPr/>
        </p:nvCxnSpPr>
        <p:spPr>
          <a:xfrm flipV="1">
            <a:off x="7134225" y="381000"/>
            <a:ext cx="17056" cy="20574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500039" y="3048000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28" name="Straight Connector 27"/>
          <p:cNvCxnSpPr>
            <a:endCxn id="27" idx="0"/>
          </p:cNvCxnSpPr>
          <p:nvPr/>
        </p:nvCxnSpPr>
        <p:spPr>
          <a:xfrm flipV="1">
            <a:off x="7098120" y="3048000"/>
            <a:ext cx="0" cy="278639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59740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990600"/>
            <a:ext cx="5257800" cy="3754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 smtClean="0"/>
              <a:t>CL2: </a:t>
            </a:r>
            <a:r>
              <a:rPr lang="en-US" sz="1400" b="1" u="sng" dirty="0"/>
              <a:t>Early </a:t>
            </a:r>
            <a:r>
              <a:rPr lang="en-US" sz="1400" b="1" u="sng" dirty="0" smtClean="0"/>
              <a:t>Stable </a:t>
            </a:r>
            <a:r>
              <a:rPr lang="en-US" sz="1400" b="1" u="sng" dirty="0"/>
              <a:t>Stage</a:t>
            </a:r>
          </a:p>
          <a:p>
            <a:r>
              <a:rPr lang="en-US" sz="1400" b="1" dirty="0" smtClean="0"/>
              <a:t>CL2-U: Cluster 2-Upregulated pathways</a:t>
            </a:r>
          </a:p>
          <a:p>
            <a:endParaRPr lang="en-US" sz="1400" b="1" dirty="0" smtClean="0"/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Earliest anti-pathogen activities:</a:t>
            </a:r>
            <a:r>
              <a:rPr lang="en-US" sz="1400" dirty="0"/>
              <a:t> </a:t>
            </a:r>
            <a:r>
              <a:rPr lang="en-US" sz="1400" dirty="0" smtClean="0"/>
              <a:t>MLKL involved in virus control and pathogenesis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NOXA expression enhances cellular sensitivity to virus or dsRNA-induced apoptosis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Activation of caspase-7 in response to pore formation represents an adaptive mechanism by which host cells can protect membrane integrity during infection. </a:t>
            </a:r>
            <a:endParaRPr lang="en-US" sz="1400" dirty="0" smtClean="0">
              <a:solidFill>
                <a:srgbClr val="FF0000"/>
              </a:solidFill>
            </a:endParaRPr>
          </a:p>
          <a:p>
            <a:endParaRPr lang="en-US" sz="1400" b="1" dirty="0" smtClean="0"/>
          </a:p>
          <a:p>
            <a:r>
              <a:rPr lang="en-US" sz="1400" b="1" dirty="0" smtClean="0"/>
              <a:t>CL2-D: Cluster 2-Downregulated pathways</a:t>
            </a:r>
            <a:endParaRPr lang="en-US" sz="1400" dirty="0" smtClean="0">
              <a:solidFill>
                <a:srgbClr val="FF0000"/>
              </a:solidFill>
            </a:endParaRP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Members of PRR family (ZAP- a unique member of the cytosolic RNA-sensing PRR family that targets and eliminates intracellular RNA viruses independently of TLR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TRIM25 a pivotal activator for RIG-I receptors,  DDX3X-IFN pathway regulator)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7849" y="1635592"/>
            <a:ext cx="3105150" cy="342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0448" y="3479129"/>
            <a:ext cx="3102552" cy="2944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5"/>
          <p:cNvCxnSpPr/>
          <p:nvPr/>
        </p:nvCxnSpPr>
        <p:spPr>
          <a:xfrm>
            <a:off x="5628414" y="153296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5999888" y="118497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009414" y="120737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390414" y="120737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390414" y="1228160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2-U</a:t>
            </a:r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6780940" y="1203915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5628414" y="301153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5999888" y="3011538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6009414" y="3338746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6390414" y="3338746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390414" y="3011538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2-D</a:t>
            </a:r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6780940" y="3335283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38200" y="422970"/>
            <a:ext cx="494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arly changes: 4.0 hour Post-Infection [continued]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410200" y="3742016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24 h 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410200" y="194697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</a:t>
            </a:r>
            <a:r>
              <a:rPr lang="en-US" sz="1600" b="1" smtClean="0"/>
              <a:t>24 h  </a:t>
            </a:r>
            <a:endParaRPr lang="en-US" sz="1600" b="1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8168616" y="6360459"/>
            <a:ext cx="975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5B Fig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576239" y="685800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23" name="Straight Connector 22"/>
          <p:cNvCxnSpPr>
            <a:endCxn id="22" idx="0"/>
          </p:cNvCxnSpPr>
          <p:nvPr/>
        </p:nvCxnSpPr>
        <p:spPr>
          <a:xfrm flipV="1">
            <a:off x="7174320" y="685800"/>
            <a:ext cx="0" cy="308773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95568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1295400"/>
            <a:ext cx="5181600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u="sng" dirty="0" smtClean="0"/>
              <a:t>CL3: Intermediate </a:t>
            </a:r>
            <a:r>
              <a:rPr lang="en-US" sz="1400" b="1" u="sng" dirty="0"/>
              <a:t>Transitory Stage</a:t>
            </a:r>
          </a:p>
          <a:p>
            <a:r>
              <a:rPr lang="en-US" sz="1400" dirty="0" smtClean="0"/>
              <a:t>Genes that temporarily inhibited by virus activity, but later are activated to participate in the earliest events of innate immunity activation</a:t>
            </a:r>
          </a:p>
          <a:p>
            <a:endParaRPr lang="en-US" sz="1400" b="1" dirty="0" smtClean="0"/>
          </a:p>
          <a:p>
            <a:r>
              <a:rPr lang="en-US" sz="1400" b="1" dirty="0"/>
              <a:t>CL3-U: Cluster 3-Upregulated genes</a:t>
            </a:r>
            <a:r>
              <a:rPr lang="en-US" sz="1400" dirty="0"/>
              <a:t>: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Leukocyte recruitment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Mechanisms inhibiting LSR/RPR activation and function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Creation of conditions for activation acute phase response signaling  (</a:t>
            </a:r>
            <a:r>
              <a:rPr lang="en-US" sz="1400" dirty="0"/>
              <a:t>IL-6, IL-8 signaling, PRR signaling, TLR signaling, chemokine signaling, complement system, Fc gamma receptor mediated Phagocytosis</a:t>
            </a:r>
            <a:r>
              <a:rPr lang="en-US" sz="1400" dirty="0" smtClean="0"/>
              <a:t>)</a:t>
            </a:r>
          </a:p>
          <a:p>
            <a:pPr marL="285750" indent="-285750">
              <a:buFont typeface="Arial" pitchFamily="34" charset="0"/>
              <a:buChar char="•"/>
            </a:pPr>
            <a:endParaRPr lang="en-US" sz="1400" b="1" dirty="0" smtClean="0"/>
          </a:p>
          <a:p>
            <a:r>
              <a:rPr lang="en-US" sz="1400" b="1" dirty="0" smtClean="0"/>
              <a:t>CL3-D</a:t>
            </a:r>
            <a:r>
              <a:rPr lang="en-US" sz="1400" b="1" dirty="0"/>
              <a:t>: Cluster 3-Downregulated genes</a:t>
            </a:r>
            <a:r>
              <a:rPr lang="en-US" sz="1400" dirty="0"/>
              <a:t>: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Cell migration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Apoptotic induction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14400" y="621268"/>
            <a:ext cx="464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ntermediate  changes: 8.0 hour Post-Infection </a:t>
            </a:r>
          </a:p>
        </p:txBody>
      </p:sp>
      <p:pic>
        <p:nvPicPr>
          <p:cNvPr id="4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0394" y="1960418"/>
            <a:ext cx="3095624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70394" y="4648200"/>
            <a:ext cx="3116406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5"/>
          <p:cNvCxnSpPr/>
          <p:nvPr/>
        </p:nvCxnSpPr>
        <p:spPr>
          <a:xfrm>
            <a:off x="5563468" y="1427018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6336724" y="1394219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944468" y="1742209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6700405" y="1394219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6325468" y="142008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676160" y="1372877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3-U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5564333" y="4462790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5935807" y="4114800"/>
            <a:ext cx="0" cy="34799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945333" y="4137208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6326333" y="4461164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692328" y="4157990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3-D</a:t>
            </a:r>
            <a:endParaRPr lang="en-US" dirty="0"/>
          </a:p>
        </p:txBody>
      </p:sp>
      <p:cxnSp>
        <p:nvCxnSpPr>
          <p:cNvPr id="17" name="Straight Connector 16"/>
          <p:cNvCxnSpPr/>
          <p:nvPr/>
        </p:nvCxnSpPr>
        <p:spPr>
          <a:xfrm>
            <a:off x="6716859" y="4133745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6707333" y="175260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512070" y="914400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20" name="Straight Connector 19"/>
          <p:cNvCxnSpPr>
            <a:stCxn id="5" idx="2"/>
            <a:endCxn id="19" idx="0"/>
          </p:cNvCxnSpPr>
          <p:nvPr/>
        </p:nvCxnSpPr>
        <p:spPr>
          <a:xfrm flipH="1" flipV="1">
            <a:off x="7110151" y="914400"/>
            <a:ext cx="18446" cy="411480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V="1">
            <a:off x="5959187" y="1406236"/>
            <a:ext cx="0" cy="34799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V="1">
            <a:off x="6315942" y="411480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V="1">
            <a:off x="6721187" y="4114800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334000" y="3471446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 24 h 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334000" y="5029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24 h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8018797" y="6355562"/>
            <a:ext cx="1040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5C Fi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6917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62000" y="468868"/>
            <a:ext cx="3701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ate changes: 24 hour Post-Infection </a:t>
            </a:r>
          </a:p>
        </p:txBody>
      </p:sp>
      <p:sp>
        <p:nvSpPr>
          <p:cNvPr id="3" name="Rectangle 2"/>
          <p:cNvSpPr/>
          <p:nvPr/>
        </p:nvSpPr>
        <p:spPr>
          <a:xfrm>
            <a:off x="228601" y="1219200"/>
            <a:ext cx="5029200" cy="4616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u="sng" dirty="0" smtClean="0"/>
              <a:t>CL4: Intermediate </a:t>
            </a:r>
            <a:r>
              <a:rPr lang="en-US" sz="1400" b="1" u="sng" dirty="0"/>
              <a:t>Stable Stage</a:t>
            </a:r>
          </a:p>
          <a:p>
            <a:r>
              <a:rPr lang="en-US" sz="1400" b="1" dirty="0" smtClean="0"/>
              <a:t>CL4: Cluster 4 genes</a:t>
            </a:r>
            <a:endParaRPr lang="en-US" sz="1400" dirty="0" smtClean="0"/>
          </a:p>
          <a:p>
            <a:r>
              <a:rPr lang="en-US" sz="1400" b="1" i="1" dirty="0" smtClean="0"/>
              <a:t>Activation of the innate immune response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Pattern Recognition Receptor Pathways (TLR signaling, RIG1-like receptors)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Interferon Signaling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Communication between Innate and Adaptive Immune Cells (beginning, 8 genes, including chemokines, cytokines, mediating Communication between Immune Cells)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Death Receptor Signaling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NFKB signaling, IL6 </a:t>
            </a:r>
            <a:r>
              <a:rPr lang="en-US" sz="1400" dirty="0" smtClean="0"/>
              <a:t>signaling</a:t>
            </a:r>
          </a:p>
          <a:p>
            <a:endParaRPr lang="en-US" sz="1400" b="1" dirty="0" smtClean="0"/>
          </a:p>
          <a:p>
            <a:r>
              <a:rPr lang="en-US" sz="1400" b="1" dirty="0" smtClean="0"/>
              <a:t>CL4-U: Cluster 4-Upregulated activities</a:t>
            </a:r>
            <a:r>
              <a:rPr lang="en-US" sz="1400" dirty="0" smtClean="0"/>
              <a:t>: </a:t>
            </a:r>
          </a:p>
          <a:p>
            <a:r>
              <a:rPr lang="en-US" sz="1400" dirty="0" smtClean="0"/>
              <a:t>Antiviral </a:t>
            </a:r>
            <a:r>
              <a:rPr lang="en-US" sz="1400" dirty="0"/>
              <a:t>innate immune response, differentiation, activation and expansion of leukocytes, cell death and survival, function of antigen presenting cells</a:t>
            </a:r>
          </a:p>
          <a:p>
            <a:endParaRPr lang="en-US" sz="1400" b="1" dirty="0" smtClean="0"/>
          </a:p>
          <a:p>
            <a:r>
              <a:rPr lang="en-US" sz="1400" b="1" dirty="0" smtClean="0"/>
              <a:t>CL4-D: Cluster 4-Downregulated activities</a:t>
            </a:r>
            <a:r>
              <a:rPr lang="en-US" sz="1400" dirty="0" smtClean="0"/>
              <a:t>: </a:t>
            </a:r>
          </a:p>
          <a:p>
            <a:r>
              <a:rPr lang="en-US" sz="1400" dirty="0" smtClean="0"/>
              <a:t>Virus replication and </a:t>
            </a:r>
            <a:r>
              <a:rPr lang="en-US" sz="1400" dirty="0"/>
              <a:t>cell </a:t>
            </a:r>
            <a:r>
              <a:rPr lang="en-US" sz="1400" dirty="0" smtClean="0"/>
              <a:t>infection, counting all events that accompanied the virus attaching to the cell surface, penetrating and incorporating into the replication machinery</a:t>
            </a:r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46594" y="1143000"/>
            <a:ext cx="3116406" cy="1962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2348" y="4210932"/>
            <a:ext cx="3140651" cy="3273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5"/>
          <p:cNvCxnSpPr/>
          <p:nvPr/>
        </p:nvCxnSpPr>
        <p:spPr>
          <a:xfrm>
            <a:off x="5653526" y="990600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6034526" y="990600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V="1">
            <a:off x="6406000" y="642610"/>
            <a:ext cx="0" cy="34799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6415526" y="665018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5695950" y="3755464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6076950" y="3755464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6448424" y="3766810"/>
            <a:ext cx="0" cy="34799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6457950" y="4081046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6447559" y="621268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4-U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6457950" y="3657600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4-D</a:t>
            </a:r>
            <a:endParaRPr lang="en-US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6787000" y="665018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838085" y="4081046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591737" y="152400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19" name="Straight Connector 18"/>
          <p:cNvCxnSpPr>
            <a:stCxn id="5" idx="2"/>
            <a:endCxn id="18" idx="0"/>
          </p:cNvCxnSpPr>
          <p:nvPr/>
        </p:nvCxnSpPr>
        <p:spPr>
          <a:xfrm flipH="1" flipV="1">
            <a:off x="7189818" y="152400"/>
            <a:ext cx="2856" cy="438584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426764" y="4538246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 24 h 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463208" y="31242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24 h 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997127" y="6390185"/>
            <a:ext cx="104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5D Fi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92483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1" y="1286232"/>
            <a:ext cx="5029200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US" sz="1400" dirty="0" smtClean="0"/>
          </a:p>
          <a:p>
            <a:r>
              <a:rPr lang="en-US" sz="1400" b="1" u="sng" dirty="0" smtClean="0"/>
              <a:t>CL5: Late Stage</a:t>
            </a:r>
            <a:endParaRPr lang="en-US" sz="1400" b="1" u="sng" dirty="0"/>
          </a:p>
          <a:p>
            <a:r>
              <a:rPr lang="en-US" sz="1400" b="1" dirty="0" smtClean="0"/>
              <a:t>CL5-U: Cluster 5-Upregulated activities</a:t>
            </a:r>
            <a:r>
              <a:rPr lang="en-US" sz="1400" dirty="0" smtClean="0"/>
              <a:t>: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Communication </a:t>
            </a:r>
            <a:r>
              <a:rPr lang="en-US" sz="1400" dirty="0"/>
              <a:t>between Innate and Adaptive Immune </a:t>
            </a:r>
            <a:r>
              <a:rPr lang="en-US" sz="1400" dirty="0" smtClean="0"/>
              <a:t>responses, </a:t>
            </a:r>
            <a:r>
              <a:rPr lang="en-US" sz="1400" dirty="0"/>
              <a:t>Antigen Presentation (chemokines, CD antigens, HLA genes)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Interferon signaling  (bottom part of pathway – IFI, IFIT, OAS genes)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SLE signaling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Cell migration, </a:t>
            </a:r>
            <a:r>
              <a:rPr lang="en-US" sz="1400" dirty="0" smtClean="0"/>
              <a:t>quantity</a:t>
            </a:r>
          </a:p>
          <a:p>
            <a:endParaRPr lang="en-US" sz="1400" b="1" dirty="0" smtClean="0"/>
          </a:p>
          <a:p>
            <a:r>
              <a:rPr lang="en-US" sz="1400" b="1" dirty="0" smtClean="0"/>
              <a:t>CL5-D: Cluster 5-Downregulated activities</a:t>
            </a:r>
            <a:r>
              <a:rPr lang="en-US" sz="1400" dirty="0" smtClean="0"/>
              <a:t>:</a:t>
            </a:r>
            <a:r>
              <a:rPr lang="en-US" sz="1400" b="1" dirty="0" smtClean="0"/>
              <a:t> 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 smtClean="0"/>
              <a:t>Mitochondrial </a:t>
            </a:r>
            <a:r>
              <a:rPr lang="en-US" sz="1400" dirty="0"/>
              <a:t>dysfunction</a:t>
            </a:r>
          </a:p>
          <a:p>
            <a:pPr marL="285750" indent="-285750">
              <a:buFont typeface="Arial" pitchFamily="34" charset="0"/>
              <a:buChar char="•"/>
            </a:pPr>
            <a:r>
              <a:rPr lang="en-US" sz="1400" dirty="0"/>
              <a:t>Viral infection, </a:t>
            </a:r>
            <a:r>
              <a:rPr lang="en-US" sz="1400" dirty="0" smtClean="0"/>
              <a:t>replication (see above)</a:t>
            </a:r>
            <a:endParaRPr 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5334000" y="5071646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</a:t>
            </a:r>
            <a:r>
              <a:rPr lang="en-US" sz="1600" b="1" dirty="0"/>
              <a:t>8</a:t>
            </a:r>
            <a:r>
              <a:rPr lang="en-US" sz="1600" b="1" dirty="0" smtClean="0"/>
              <a:t>.0  24  Mock 4.0  </a:t>
            </a:r>
            <a:r>
              <a:rPr lang="en-US" sz="1600" b="1" dirty="0"/>
              <a:t>8</a:t>
            </a:r>
            <a:r>
              <a:rPr lang="en-US" sz="1600" b="1" dirty="0" smtClean="0"/>
              <a:t>.0   24 h 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39968" y="609600"/>
            <a:ext cx="4894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Late changes: 24 hour Post-Infection [Continued] </a:t>
            </a:r>
          </a:p>
        </p:txBody>
      </p:sp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6063" y="2019300"/>
            <a:ext cx="3116406" cy="1343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62600" y="4547771"/>
            <a:ext cx="314065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" name="Straight Connector 6"/>
          <p:cNvCxnSpPr/>
          <p:nvPr/>
        </p:nvCxnSpPr>
        <p:spPr>
          <a:xfrm>
            <a:off x="5573861" y="1805315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V="1">
            <a:off x="6713393" y="1457325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5954861" y="1807152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6335861" y="1803689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867400" y="1392793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5-U</a:t>
            </a:r>
            <a:endParaRPr lang="en-US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6726387" y="1476270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5584247" y="4109516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V="1">
            <a:off x="6723779" y="4121744"/>
            <a:ext cx="0" cy="34799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5965247" y="4111353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6346247" y="4107890"/>
            <a:ext cx="371474" cy="0"/>
          </a:xfrm>
          <a:prstGeom prst="line">
            <a:avLst/>
          </a:prstGeom>
          <a:ln w="28575">
            <a:solidFill>
              <a:schemeClr val="accent5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943600" y="4102239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L5-D</a:t>
            </a:r>
            <a:endParaRPr lang="en-US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6736773" y="4471571"/>
            <a:ext cx="37147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553200" y="795754"/>
            <a:ext cx="1196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i="1" dirty="0" smtClean="0"/>
              <a:t>1125       1067</a:t>
            </a:r>
            <a:endParaRPr lang="en-US" sz="1400" b="1" i="1" dirty="0"/>
          </a:p>
        </p:txBody>
      </p:sp>
      <p:cxnSp>
        <p:nvCxnSpPr>
          <p:cNvPr id="20" name="Straight Connector 19"/>
          <p:cNvCxnSpPr>
            <a:endCxn id="19" idx="0"/>
          </p:cNvCxnSpPr>
          <p:nvPr/>
        </p:nvCxnSpPr>
        <p:spPr>
          <a:xfrm flipH="1" flipV="1">
            <a:off x="7151281" y="795754"/>
            <a:ext cx="2856" cy="430964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5334000" y="33528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  Mock  4.0   8.0  24  Mock 4.0  8.0   24 h 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115280" y="6407713"/>
            <a:ext cx="915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5E Fi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5469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637</Words>
  <Application>Microsoft Office PowerPoint</Application>
  <PresentationFormat>On-screen Show (4:3)</PresentationFormat>
  <Paragraphs>9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Kahn</dc:creator>
  <cp:lastModifiedBy>Jeffrey Kahn</cp:lastModifiedBy>
  <cp:revision>10</cp:revision>
  <dcterms:created xsi:type="dcterms:W3CDTF">2017-02-21T22:25:49Z</dcterms:created>
  <dcterms:modified xsi:type="dcterms:W3CDTF">2017-07-28T19:51:33Z</dcterms:modified>
</cp:coreProperties>
</file>